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ppt/slides/slide14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slide16.xml" ContentType="application/vnd.openxmlformats-officedocument.presentationml.slide+xml"/>
  <Override PartName="/ppt/slides/slide1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BBA16-66A0-4A01-A6B1-159A1ECD4A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E938D-24BE-4009-BF47-EC78C6F906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8BBE2-CA7B-4997-AB01-D526A2DA93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FCFF5-EBD1-4BE0-A363-1754413A12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1C125-6A59-4462-8776-C1AF2BA27A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62600-62E5-4E37-9D8A-19694A1B1B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A1D4B-F18E-4A2E-9EB2-50925C3C27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61EAE-E84C-43F8-AE7A-6F91FD2490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C31A9-F052-475F-8422-3273B36B77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B5EAC-AF64-4654-9184-19ECA2D5F0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FB8BE-E8B6-48B5-A5F3-FB88E4FDD6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3A6D2-E949-4693-9DCD-CBE086CA88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3F1A09-FEF8-42EA-B0CF-C7C8BE3308F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-304920" y="-471600"/>
            <a:ext cx="9753840" cy="780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9T15:51:58Z</dcterms:created>
  <dc:creator>Kristy Funk</dc:creator>
  <dc:description/>
  <dc:language>en-US</dc:language>
  <cp:lastModifiedBy>Gunther Eysenbach</cp:lastModifiedBy>
  <dcterms:modified xsi:type="dcterms:W3CDTF">2008-01-20T21:22:22Z</dcterms:modified>
  <cp:revision>2</cp:revision>
  <dc:subject/>
  <dc:title>Slide 1</dc:title>
</cp:coreProperties>
</file>